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5A458AC-C54E-4D0A-95CC-F5AEBF9FCBC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6473A60-FC21-437C-87C8-8019D948E60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8AB6C-F1E2-46D3-A70E-C3BF62794F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3031D-574D-4E89-9D42-F17E77C099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C8853B-FD36-4D30-993E-D2600D51F4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7B7F4-FCC4-4C35-81FA-041A941DAF8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238B45-5413-4219-8E75-8C53A45EAE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E240F0-5FA3-4E62-A9B1-B647DE135D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444279-E31F-446B-B6A0-86E65E4FA1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A3E3B-1927-4B61-B33D-B62455847F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89349E-8B74-4928-B150-4FD0629220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F4A67-9B7E-4A80-828E-660069CB2C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EEBE6-D8D8-438F-853A-8950D8304F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6A77D-366A-47EF-97DB-538EF79168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E3DCCAF-D88A-4713-9FE7-D89947A8CF1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549360" y="4441680"/>
          <a:ext cx="5607000" cy="1622520"/>
        </p:xfrm>
        <a:graphic>
          <a:graphicData uri="http://schemas.openxmlformats.org/drawingml/2006/table">
            <a:tbl>
              <a:tblPr/>
              <a:tblGrid>
                <a:gridCol w="1601640"/>
                <a:gridCol w="1319400"/>
                <a:gridCol w="790560"/>
                <a:gridCol w="322200"/>
                <a:gridCol w="1143000"/>
                <a:gridCol w="430200"/>
              </a:tblGrid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inical-pathological parameter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ro-RO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ivariate analysi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ro-RO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ltivariate analysi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da-DK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-stage (n=11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944 (1.748, 8.899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0.00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419 (3.877, 39.783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        </a:t>
                      </a: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&lt;0.00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ymph-node involvement (n=11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088 (1.394, 11.98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0.0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515 (1.492, 13.657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0.00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istological type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12 (0.498, 3.451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.724 (1.594, 155.115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0.01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pt-BR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strogen receptor status (n=11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25 (0.396, 2.164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57 (0.359, 5.913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9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56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 status (n=11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78 (0.438, 2.183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88 (0.208, 2.984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2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9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ytoplasm Score of OTUB1 (n=116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62 (0.532, 2.538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0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048 (1.342, 12.2.15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0.01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TextBox 6"/>
          <p:cNvSpPr/>
          <p:nvPr/>
        </p:nvSpPr>
        <p:spPr>
          <a:xfrm>
            <a:off x="440640" y="4114800"/>
            <a:ext cx="189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isease-specific survival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8"/>
          <p:cNvSpPr/>
          <p:nvPr/>
        </p:nvSpPr>
        <p:spPr>
          <a:xfrm>
            <a:off x="468360" y="201600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9"/>
          <p:cNvSpPr/>
          <p:nvPr/>
        </p:nvSpPr>
        <p:spPr>
          <a:xfrm>
            <a:off x="457920" y="1292400"/>
            <a:ext cx="172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ll patients (n=116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2" name=""/>
          <p:cNvGraphicFramePr/>
          <p:nvPr/>
        </p:nvGraphicFramePr>
        <p:xfrm>
          <a:off x="549360" y="2292480"/>
          <a:ext cx="5584680" cy="1623960"/>
        </p:xfrm>
        <a:graphic>
          <a:graphicData uri="http://schemas.openxmlformats.org/drawingml/2006/table">
            <a:tbl>
              <a:tblPr/>
              <a:tblGrid>
                <a:gridCol w="1616040"/>
                <a:gridCol w="1293840"/>
                <a:gridCol w="838080"/>
                <a:gridCol w="271440"/>
                <a:gridCol w="1084320"/>
                <a:gridCol w="480960"/>
              </a:tblGrid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inical-pathological parameter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ro-RO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ivariate analysi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ro-RO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ltivariate analysi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15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da-DK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-stage (n=11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892 (1.331, 6.283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0.00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689 (2.434, 18.38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           </a:t>
                      </a: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&lt;0.00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ymph-node involvement (n=11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999 (1.213, 7.411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0.01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457 (1.212, 9.862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0.0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istological type (n=11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47 (0.501, 2.62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702 (0.876, 15.65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pt-BR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strogen receptor status (n=11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7 (0.49, 2.338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4 (0.373, 4.822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5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 status (n=11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49 (0.463, 1.945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32 (0.295, 2.941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0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0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ytoplasm Score of OTUB1 (n=116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71 (0.586,2.341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5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859 (1.086, 7.527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0.03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3" name="TextBox 19"/>
          <p:cNvSpPr/>
          <p:nvPr/>
        </p:nvSpPr>
        <p:spPr>
          <a:xfrm>
            <a:off x="4640040" y="9597960"/>
            <a:ext cx="230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5:41Z</dcterms:modified>
  <cp:revision>919</cp:revision>
  <dc:subject/>
  <dc:title>PowerPoint Presentation</dc:title>
</cp:coreProperties>
</file>